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80CC07-A8CB-4092-AA46-A8CF5BAFDE0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1E3FA50-1B08-4CA3-8E12-D3FD0830733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482E2-B19D-4BAE-8F85-35A7374E27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9C79A-69DD-425B-82BD-E8CC29D9CD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FC5D76-D0FC-4492-91C8-D1695823DFC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3E4B5-A80B-440A-A409-1AD729F17F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FCAFC-7507-47C3-955D-BBDCBBC935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358BE-4797-440A-BB68-0A580EBEE5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D0B14-7A15-42E1-BAAE-3E274B990C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5DD0A-706B-4A98-A898-FAD2E2E64F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2DA5F-D20B-4067-AC28-95628B1E9C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26599-1F45-4AAF-8B70-0EC040C4D0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7920FC-3AF6-4AB1-842B-1C9BFB3426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9F159-7B18-4A48-A19A-7ABEC85835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D31821-219E-448A-98B5-85A7BD7D21E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Exp_test_S2_v2.tif"/>
          <p:cNvPicPr/>
          <p:nvPr/>
        </p:nvPicPr>
        <p:blipFill>
          <a:blip r:embed="rId1"/>
          <a:stretch/>
        </p:blipFill>
        <p:spPr>
          <a:xfrm>
            <a:off x="403200" y="1219320"/>
            <a:ext cx="6051600" cy="427968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1"/>
          <p:cNvSpPr/>
          <p:nvPr/>
        </p:nvSpPr>
        <p:spPr>
          <a:xfrm>
            <a:off x="360360" y="5905080"/>
            <a:ext cx="609588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2: Evidence for past recombination events in PI-2 pilus islets of Mitis group streptococci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. Schematic overview of PI-2 pilus islets. Sequences of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oral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Uo5 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. sp. C300 are not shown (almost identical to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sanguinis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TCC49296). Gene regions encoding conserved motifs are indicated by a black bar below the gene. SP: Signal peptide, vWA: von Willebrand A domain, CWSS: cell wall sorting signal. Red squares indicate the regions of sudden, major changes in sequence polymorphisms aligned in panels B.-E. In panels B.-E. Regions of major sequence polymorphisms are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ndicated in grey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GenBank accession numbers: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oral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strains ATCC35037:  AEDW01000020; ATCC10557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: JF496566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S. oral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34: JF496567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mit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ATCC6249:  AEEN01000012;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sanguin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ATCC49296:  AEPO01000013; 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pneumonia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GA47884:  GU256423. Alignment was performed with ClustalW software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380880" y="685800"/>
            <a:ext cx="8001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vidence for past recombination events in PI-2 of Mitis group streptococci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02T18:21:43Z</dcterms:created>
  <dc:creator>dzahner</dc:creator>
  <dc:description/>
  <dc:language>en-US</dc:language>
  <cp:lastModifiedBy>dzahner</cp:lastModifiedBy>
  <dcterms:modified xsi:type="dcterms:W3CDTF">2011-08-02T19:00:14Z</dcterms:modified>
  <cp:revision>7</cp:revision>
  <dc:subject/>
  <dc:title>Slide 1</dc:title>
</cp:coreProperties>
</file>